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sldIdLst>
    <p:sldId id="256" r:id="rId2"/>
  </p:sldIdLst>
  <p:sldSz cx="9601200" cy="12801600" type="A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sz="3360" kern="1200">
        <a:solidFill>
          <a:schemeClr val="tx1"/>
        </a:solidFill>
        <a:latin typeface="Times New Roman" panose="02020603050405020304" pitchFamily="18" charset="0"/>
        <a:ea typeface="+mn-ea"/>
        <a:cs typeface="+mn-cs"/>
      </a:defRPr>
    </a:lvl1pPr>
    <a:lvl2pPr marL="640080" algn="l" rtl="0" eaLnBrk="0" fontAlgn="base" hangingPunct="0">
      <a:spcBef>
        <a:spcPct val="0"/>
      </a:spcBef>
      <a:spcAft>
        <a:spcPct val="0"/>
      </a:spcAft>
      <a:defRPr sz="3360" kern="1200">
        <a:solidFill>
          <a:schemeClr val="tx1"/>
        </a:solidFill>
        <a:latin typeface="Times New Roman" panose="02020603050405020304" pitchFamily="18" charset="0"/>
        <a:ea typeface="+mn-ea"/>
        <a:cs typeface="+mn-cs"/>
      </a:defRPr>
    </a:lvl2pPr>
    <a:lvl3pPr marL="1280160" algn="l" rtl="0" eaLnBrk="0" fontAlgn="base" hangingPunct="0">
      <a:spcBef>
        <a:spcPct val="0"/>
      </a:spcBef>
      <a:spcAft>
        <a:spcPct val="0"/>
      </a:spcAft>
      <a:defRPr sz="3360" kern="1200">
        <a:solidFill>
          <a:schemeClr val="tx1"/>
        </a:solidFill>
        <a:latin typeface="Times New Roman" panose="02020603050405020304" pitchFamily="18" charset="0"/>
        <a:ea typeface="+mn-ea"/>
        <a:cs typeface="+mn-cs"/>
      </a:defRPr>
    </a:lvl3pPr>
    <a:lvl4pPr marL="1920240" algn="l" rtl="0" eaLnBrk="0" fontAlgn="base" hangingPunct="0">
      <a:spcBef>
        <a:spcPct val="0"/>
      </a:spcBef>
      <a:spcAft>
        <a:spcPct val="0"/>
      </a:spcAft>
      <a:defRPr sz="3360" kern="1200">
        <a:solidFill>
          <a:schemeClr val="tx1"/>
        </a:solidFill>
        <a:latin typeface="Times New Roman" panose="02020603050405020304" pitchFamily="18" charset="0"/>
        <a:ea typeface="+mn-ea"/>
        <a:cs typeface="+mn-cs"/>
      </a:defRPr>
    </a:lvl4pPr>
    <a:lvl5pPr marL="2560320" algn="l" rtl="0" eaLnBrk="0" fontAlgn="base" hangingPunct="0">
      <a:spcBef>
        <a:spcPct val="0"/>
      </a:spcBef>
      <a:spcAft>
        <a:spcPct val="0"/>
      </a:spcAft>
      <a:defRPr sz="3360" kern="1200">
        <a:solidFill>
          <a:schemeClr val="tx1"/>
        </a:solidFill>
        <a:latin typeface="Times New Roman" panose="02020603050405020304" pitchFamily="18" charset="0"/>
        <a:ea typeface="+mn-ea"/>
        <a:cs typeface="+mn-cs"/>
      </a:defRPr>
    </a:lvl5pPr>
    <a:lvl6pPr marL="3200400" algn="l" defTabSz="1280160" rtl="0" eaLnBrk="1" latinLnBrk="0" hangingPunct="1">
      <a:defRPr sz="3360" kern="1200">
        <a:solidFill>
          <a:schemeClr val="tx1"/>
        </a:solidFill>
        <a:latin typeface="Times New Roman" panose="02020603050405020304" pitchFamily="18" charset="0"/>
        <a:ea typeface="+mn-ea"/>
        <a:cs typeface="+mn-cs"/>
      </a:defRPr>
    </a:lvl6pPr>
    <a:lvl7pPr marL="3840480" algn="l" defTabSz="1280160" rtl="0" eaLnBrk="1" latinLnBrk="0" hangingPunct="1">
      <a:defRPr sz="3360" kern="1200">
        <a:solidFill>
          <a:schemeClr val="tx1"/>
        </a:solidFill>
        <a:latin typeface="Times New Roman" panose="02020603050405020304" pitchFamily="18" charset="0"/>
        <a:ea typeface="+mn-ea"/>
        <a:cs typeface="+mn-cs"/>
      </a:defRPr>
    </a:lvl7pPr>
    <a:lvl8pPr marL="4480560" algn="l" defTabSz="1280160" rtl="0" eaLnBrk="1" latinLnBrk="0" hangingPunct="1">
      <a:defRPr sz="3360" kern="1200">
        <a:solidFill>
          <a:schemeClr val="tx1"/>
        </a:solidFill>
        <a:latin typeface="Times New Roman" panose="02020603050405020304" pitchFamily="18" charset="0"/>
        <a:ea typeface="+mn-ea"/>
        <a:cs typeface="+mn-cs"/>
      </a:defRPr>
    </a:lvl8pPr>
    <a:lvl9pPr marL="5120640" algn="l" defTabSz="1280160" rtl="0" eaLnBrk="1" latinLnBrk="0" hangingPunct="1">
      <a:defRPr sz="3360" kern="1200">
        <a:solidFill>
          <a:schemeClr val="tx1"/>
        </a:solidFill>
        <a:latin typeface="Times New Roman" panose="02020603050405020304" pitchFamily="18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2" autoAdjust="0"/>
    <p:restoredTop sz="90929"/>
  </p:normalViewPr>
  <p:slideViewPr>
    <p:cSldViewPr snapToGrid="0">
      <p:cViewPr>
        <p:scale>
          <a:sx n="75" d="100"/>
          <a:sy n="75" d="100"/>
        </p:scale>
        <p:origin x="-656" y="-16"/>
      </p:cViewPr>
      <p:guideLst>
        <p:guide orient="horz" pos="4032"/>
        <p:guide pos="302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200150" y="2095078"/>
            <a:ext cx="720090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200150" y="6723805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9DFB9F-58C4-48AC-B3FD-04FF0DE905CC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170015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AEDEAB2-F546-4415-B84E-D0C980364012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2957665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840855" y="1137920"/>
            <a:ext cx="2040255" cy="1024128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720090" y="1137920"/>
            <a:ext cx="5960745" cy="1024128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C980D8-CA1B-4896-B817-AD356096BD94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314215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69FC635-0D6E-4A36-836C-9FC31409E1E8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380110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55082" y="3191512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55082" y="8566999"/>
            <a:ext cx="8281035" cy="2800349"/>
          </a:xfrm>
        </p:spPr>
        <p:txBody>
          <a:bodyPr/>
          <a:lstStyle>
            <a:lvl1pPr marL="0" indent="0">
              <a:buNone/>
              <a:defRPr sz="2520"/>
            </a:lvl1pPr>
            <a:lvl2pPr marL="480060" indent="0">
              <a:buNone/>
              <a:defRPr sz="2100"/>
            </a:lvl2pPr>
            <a:lvl3pPr marL="960120" indent="0">
              <a:buNone/>
              <a:defRPr sz="1890"/>
            </a:lvl3pPr>
            <a:lvl4pPr marL="1440180" indent="0">
              <a:buNone/>
              <a:defRPr sz="1680"/>
            </a:lvl4pPr>
            <a:lvl5pPr marL="1920240" indent="0">
              <a:buNone/>
              <a:defRPr sz="1680"/>
            </a:lvl5pPr>
            <a:lvl6pPr marL="2400300" indent="0">
              <a:buNone/>
              <a:defRPr sz="1680"/>
            </a:lvl6pPr>
            <a:lvl7pPr marL="2880360" indent="0">
              <a:buNone/>
              <a:defRPr sz="1680"/>
            </a:lvl7pPr>
            <a:lvl8pPr marL="3360420" indent="0">
              <a:buNone/>
              <a:defRPr sz="1680"/>
            </a:lvl8pPr>
            <a:lvl9pPr marL="3840480" indent="0">
              <a:buNone/>
              <a:defRPr sz="168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7822A8-A74A-4F52-B91E-403314F4D472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522848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720090" y="3698240"/>
            <a:ext cx="4000500" cy="7680960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880610" y="3698240"/>
            <a:ext cx="4000500" cy="7680960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0E40408-308B-448B-98D5-D1364A9477BC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214308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61750" y="681568"/>
            <a:ext cx="8281035" cy="2474384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61751" y="3138172"/>
            <a:ext cx="4062174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61751" y="4676141"/>
            <a:ext cx="4062174" cy="6877897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860608" y="3138172"/>
            <a:ext cx="408217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860608" y="4676141"/>
            <a:ext cx="4082177" cy="6877897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5807F7D-30A9-41B5-93F2-C1CE9D436481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4223853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A1088D2-693E-40C5-B5C3-137FDA5E2C74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2099390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94BCBF6-9FA4-4DBA-9238-4A7D9832684E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250566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61751" y="853440"/>
            <a:ext cx="3097054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082177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61751" y="3840481"/>
            <a:ext cx="3097054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C82C719-093C-479B-BA1D-9BFDBF5BE144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932913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61751" y="853440"/>
            <a:ext cx="3097054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4082177" y="1843196"/>
            <a:ext cx="4860608" cy="9097433"/>
          </a:xfrm>
        </p:spPr>
        <p:txBody>
          <a:bodyPr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de-DE" smtClean="0"/>
              <a:t>Bild durch Klicken auf Symbol hinzufügen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61751" y="3840481"/>
            <a:ext cx="3097054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822C2B-0B3B-4B6E-B7C8-98125F9778D3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013163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720090" y="1137920"/>
            <a:ext cx="8161020" cy="2133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 smtClean="0"/>
              <a:t>Hier klicken, um Master-Titelformat zu bearbeiten.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720090" y="3698240"/>
            <a:ext cx="8161020" cy="76809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 smtClean="0"/>
              <a:t>Hier klicken, um Master-Textformat zu bearbeiten.</a:t>
            </a:r>
          </a:p>
          <a:p>
            <a:pPr lvl="1"/>
            <a:r>
              <a:rPr lang="en-US" altLang="de-DE" smtClean="0"/>
              <a:t>Zweite Ebene</a:t>
            </a:r>
          </a:p>
          <a:p>
            <a:pPr lvl="2"/>
            <a:r>
              <a:rPr lang="en-US" altLang="de-DE" smtClean="0"/>
              <a:t>Dritte Ebene</a:t>
            </a:r>
          </a:p>
          <a:p>
            <a:pPr lvl="3"/>
            <a:r>
              <a:rPr lang="en-US" altLang="de-DE" smtClean="0"/>
              <a:t>Vierte Ebene</a:t>
            </a:r>
          </a:p>
          <a:p>
            <a:pPr lvl="4"/>
            <a:r>
              <a:rPr lang="en-US" alt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720090" y="11663680"/>
            <a:ext cx="2000250" cy="853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70"/>
            </a:lvl1pPr>
          </a:lstStyle>
          <a:p>
            <a:endParaRPr lang="en-US" alt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280410" y="11663680"/>
            <a:ext cx="3040380" cy="853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70"/>
            </a:lvl1pPr>
          </a:lstStyle>
          <a:p>
            <a:endParaRPr lang="en-US" alt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880860" y="11663680"/>
            <a:ext cx="2000250" cy="853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70"/>
            </a:lvl1pPr>
          </a:lstStyle>
          <a:p>
            <a:fld id="{4D25F4AB-E4BC-4598-A470-A91593F8D5B3}" type="slidenum">
              <a:rPr lang="en-US" altLang="de-DE"/>
              <a:pPr/>
              <a:t>‹#›</a:t>
            </a:fld>
            <a:endParaRPr lang="en-US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sz="462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sz="4620">
          <a:solidFill>
            <a:schemeClr val="tx2"/>
          </a:solidFill>
          <a:latin typeface="Times New Roman" panose="02020603050405020304" pitchFamily="18" charset="0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sz="4620">
          <a:solidFill>
            <a:schemeClr val="tx2"/>
          </a:solidFill>
          <a:latin typeface="Times New Roman" panose="02020603050405020304" pitchFamily="18" charset="0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sz="4620">
          <a:solidFill>
            <a:schemeClr val="tx2"/>
          </a:solidFill>
          <a:latin typeface="Times New Roman" panose="02020603050405020304" pitchFamily="18" charset="0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sz="4620">
          <a:solidFill>
            <a:schemeClr val="tx2"/>
          </a:solidFill>
          <a:latin typeface="Times New Roman" panose="02020603050405020304" pitchFamily="18" charset="0"/>
        </a:defRPr>
      </a:lvl5pPr>
      <a:lvl6pPr marL="480060" algn="ctr" rtl="0" eaLnBrk="1" fontAlgn="base" hangingPunct="1">
        <a:spcBef>
          <a:spcPct val="0"/>
        </a:spcBef>
        <a:spcAft>
          <a:spcPct val="0"/>
        </a:spcAft>
        <a:defRPr sz="4620">
          <a:solidFill>
            <a:schemeClr val="tx2"/>
          </a:solidFill>
          <a:latin typeface="Times New Roman" panose="02020603050405020304" pitchFamily="18" charset="0"/>
        </a:defRPr>
      </a:lvl6pPr>
      <a:lvl7pPr marL="960120" algn="ctr" rtl="0" eaLnBrk="1" fontAlgn="base" hangingPunct="1">
        <a:spcBef>
          <a:spcPct val="0"/>
        </a:spcBef>
        <a:spcAft>
          <a:spcPct val="0"/>
        </a:spcAft>
        <a:defRPr sz="4620">
          <a:solidFill>
            <a:schemeClr val="tx2"/>
          </a:solidFill>
          <a:latin typeface="Times New Roman" panose="02020603050405020304" pitchFamily="18" charset="0"/>
        </a:defRPr>
      </a:lvl7pPr>
      <a:lvl8pPr marL="1440180" algn="ctr" rtl="0" eaLnBrk="1" fontAlgn="base" hangingPunct="1">
        <a:spcBef>
          <a:spcPct val="0"/>
        </a:spcBef>
        <a:spcAft>
          <a:spcPct val="0"/>
        </a:spcAft>
        <a:defRPr sz="4620">
          <a:solidFill>
            <a:schemeClr val="tx2"/>
          </a:solidFill>
          <a:latin typeface="Times New Roman" panose="02020603050405020304" pitchFamily="18" charset="0"/>
        </a:defRPr>
      </a:lvl8pPr>
      <a:lvl9pPr marL="1920240" algn="ctr" rtl="0" eaLnBrk="1" fontAlgn="base" hangingPunct="1">
        <a:spcBef>
          <a:spcPct val="0"/>
        </a:spcBef>
        <a:spcAft>
          <a:spcPct val="0"/>
        </a:spcAft>
        <a:defRPr sz="4620">
          <a:solidFill>
            <a:schemeClr val="tx2"/>
          </a:solidFill>
          <a:latin typeface="Times New Roman" panose="02020603050405020304" pitchFamily="18" charset="0"/>
        </a:defRPr>
      </a:lvl9pPr>
    </p:titleStyle>
    <p:bodyStyle>
      <a:lvl1pPr marL="360045" indent="-360045" algn="l" rtl="0" eaLnBrk="1" fontAlgn="base" hangingPunct="1">
        <a:spcBef>
          <a:spcPct val="20000"/>
        </a:spcBef>
        <a:spcAft>
          <a:spcPct val="0"/>
        </a:spcAft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780098" indent="-300038" algn="l" rtl="0" eaLnBrk="1" fontAlgn="base" hangingPunct="1">
        <a:spcBef>
          <a:spcPct val="20000"/>
        </a:spcBef>
        <a:spcAft>
          <a:spcPct val="0"/>
        </a:spcAft>
        <a:buChar char="–"/>
        <a:defRPr sz="294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rtl="0" eaLnBrk="1" fontAlgn="base" hangingPunct="1">
        <a:spcBef>
          <a:spcPct val="20000"/>
        </a:spcBef>
        <a:spcAft>
          <a:spcPct val="0"/>
        </a:spcAft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rtl="0" eaLnBrk="1" fontAlgn="base" hangingPunct="1">
        <a:spcBef>
          <a:spcPct val="20000"/>
        </a:spcBef>
        <a:spcAft>
          <a:spcPct val="0"/>
        </a:spcAft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rtl="0" eaLnBrk="1" fontAlgn="base" hangingPunct="1">
        <a:spcBef>
          <a:spcPct val="20000"/>
        </a:spcBef>
        <a:spcAft>
          <a:spcPct val="0"/>
        </a:spcAft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5363376"/>
              </p:ext>
            </p:extLst>
          </p:nvPr>
        </p:nvGraphicFramePr>
        <p:xfrm>
          <a:off x="262618" y="1025866"/>
          <a:ext cx="9075964" cy="10756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04440"/>
                <a:gridCol w="538415"/>
                <a:gridCol w="976738"/>
                <a:gridCol w="6180260"/>
                <a:gridCol w="276111"/>
              </a:tblGrid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 dirty="0">
                          <a:effectLst/>
                        </a:rPr>
                        <a:t> </a:t>
                      </a:r>
                      <a:endParaRPr lang="de-DE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4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20814"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6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20814">
                <a:tc>
                  <a:txBody>
                    <a:bodyPr/>
                    <a:lstStyle/>
                    <a:p>
                      <a:pPr algn="l" fontAlgn="b"/>
                      <a:endParaRPr lang="de-DE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6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20814">
                <a:tc>
                  <a:txBody>
                    <a:bodyPr/>
                    <a:lstStyle/>
                    <a:p>
                      <a:pPr algn="l" fontAlgn="b"/>
                      <a:endParaRPr lang="de-DE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6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20814">
                <a:tc>
                  <a:txBody>
                    <a:bodyPr/>
                    <a:lstStyle/>
                    <a:p>
                      <a:pPr algn="l" fontAlgn="b"/>
                      <a:endParaRPr lang="de-DE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6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20814">
                <a:tc>
                  <a:txBody>
                    <a:bodyPr/>
                    <a:lstStyle/>
                    <a:p>
                      <a:pPr algn="l" fontAlgn="b"/>
                      <a:endParaRPr lang="de-DE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6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00102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4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DECIDUOUS WOODY PLANTS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Acer campestre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3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8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g</a:t>
                      </a:r>
                      <a:r>
                        <a:rPr lang="de-DE" sz="500" u="none" strike="noStrike" baseline="-25000">
                          <a:effectLst/>
                        </a:rPr>
                        <a:t>min</a:t>
                      </a:r>
                      <a:r>
                        <a:rPr lang="de-DE" sz="500" u="none" strike="noStrike">
                          <a:effectLst/>
                        </a:rPr>
                        <a:t>, 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Cydonia oblong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9.5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Euonymus europaeus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3.7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Fagus sylvatic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3.74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Kerstiens and Lendzian 19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Kerstiens G, Lendzian KJ (1989) Interactions between ozone and plant cuticles II. Water permeability. New Phytologist 112, 21-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3.9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g</a:t>
                      </a:r>
                      <a:r>
                        <a:rPr lang="de-DE" sz="500" u="none" strike="noStrike" baseline="-25000">
                          <a:effectLst/>
                        </a:rPr>
                        <a:t>min</a:t>
                      </a:r>
                      <a:r>
                        <a:rPr lang="de-DE" sz="500" u="none" strike="noStrike">
                          <a:effectLst/>
                        </a:rPr>
                        <a:t>, 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.21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Kerstiens and Lendzian 19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Kerstiens G, Lendzian KJ (1989) Interactions between ozone and plant cuticles II. Water permeability. New Phytologist 112, 21-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.3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Forsythia × intermedi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.7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Forsythia suspens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68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Ginkgo bilob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26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Juglans regi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99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3.5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g</a:t>
                      </a:r>
                      <a:r>
                        <a:rPr lang="de-DE" sz="500" u="none" strike="noStrike" baseline="-25000">
                          <a:effectLst/>
                        </a:rPr>
                        <a:t>min</a:t>
                      </a:r>
                      <a:r>
                        <a:rPr lang="de-DE" sz="500" u="none" strike="noStrike">
                          <a:effectLst/>
                        </a:rPr>
                        <a:t>, Burghardt and 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6) Cuticular transpiration. In: Riederer M, Müller C (eds) Biology of the plant cuticle. Blackwell Publishing, Oxford, UK, 292-31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Ligustrum vulgare 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88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Liriodendron tulipifer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35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82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Pyrus communis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9.8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22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ecker et al. 19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Becker M, Kerstiens G, Schönherr J (1986) Water permeability of plant cuticles: permeance, diffusion and partition coefficients. Trees 1, 54-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1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önherr and Lendzian 19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Schönherr J, Lendzian K (1981) A Simple and Inexpensive Method of Measuring Water Permeability of Isolated Plant Cuticular Membranes. Zeitschrift für Pflanzenohysiologie 102, 321-3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Quercus petrae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5.3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5.8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g</a:t>
                      </a:r>
                      <a:r>
                        <a:rPr lang="de-DE" sz="500" u="none" strike="noStrike" baseline="-25000">
                          <a:effectLst/>
                        </a:rPr>
                        <a:t>min</a:t>
                      </a:r>
                      <a:r>
                        <a:rPr lang="de-DE" sz="500" u="none" strike="noStrike">
                          <a:effectLst/>
                        </a:rPr>
                        <a:t>, 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Median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10E-05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Upper CI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3.16E-05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Lower CI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04E-05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N species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2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N data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1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p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0.05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00102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4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EVERGREEN WOODY PLANTS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Agastachys odorat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5.9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g</a:t>
                      </a:r>
                      <a:r>
                        <a:rPr lang="de-DE" sz="500" u="none" strike="noStrike" baseline="-25000">
                          <a:effectLst/>
                        </a:rPr>
                        <a:t>min</a:t>
                      </a:r>
                      <a:r>
                        <a:rPr lang="de-DE" sz="500" u="none" strike="noStrike">
                          <a:effectLst/>
                        </a:rPr>
                        <a:t>, Jordan and Brodribb 20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u="none" strike="noStrike">
                          <a:effectLst/>
                        </a:rPr>
                        <a:t>Jordan GJ, Brodribb TJ (2007) Incontinence in aging leaves: deteriorating water relations with leaf age in Agastachys odorata (Proteaceae), a shrub with very long-lived leaves. Functional Plant Biology 34, 318-32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Camellia sinensis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.68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5.8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Citrus aurantium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5.5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5.5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2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ecker et al. 19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Becker M, Kerstiens G, Schönherr J (1986) Water permeability of plant cuticles: permeance, diffusion and partition coefficients. Trees 1, 54-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569602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3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Kerstiens and Lendzian 19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Kerstiens G, Lendzian KJ (1989) Interactions between ozone and plant cuticles II. Water permeability. New Phytologist 112, 21-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5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önherr and Schmidt 19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u="none" strike="noStrike">
                          <a:effectLst/>
                        </a:rPr>
                        <a:t>Schönherr J, Schmidt HW (1979) Water Permeability of Plant Cuticles, Dependence of permeability Coefficients of Cuticular Transpiration on Vapor Pressure Saturation Defict. Planta 144, 391-4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8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önherr and Schmidt 19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u="none" strike="noStrike">
                          <a:effectLst/>
                        </a:rPr>
                        <a:t>Schönherr J, Schmidt HW (1979) Water Permeability of Plant Cuticles, Dependence of permeability Coefficients of Cuticular Transpiration on Vapor Pressure Saturation Defict. Planta 144, 391-4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78932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3.6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önherr and Lendzian 19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Schönherr J, Lendzian K (1981) A Simple and Inexpensive Method of Measuring Water Permeability of Isolated Plant Cuticular Membranes. Zeitschrift für Pflanzenohysiologie 102, 321-3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.5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Lendzian et al. 19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Lendzian KJ, Nakajima A, Ziegler H (1986) Isolation of cuticular membranes from various conifer needles. Trees 1, 47-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.7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Haas and Schönherr 19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Haas K, Schönherr J (1979) Composition of Soluble Cuticular Lipids and Water Permeability of Cuticular Membranes from Citrus Leaves. Planta 146, 399-40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6.0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önherr 19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u="none" strike="noStrike">
                          <a:effectLst/>
                        </a:rPr>
                        <a:t>Schönherr J (1976) Water Permeability of Isolated Cutiuclar Membranes: The Effect of Cuticular Waxes on Diffusion of Water. Planta 131, 159-16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6.9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Geyer and Schönherr 199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Geyer U, Schönherr J (1990) The effect of the environment on the permeability and composition of Citrus leaf cuticles. I. Water permeability of isolated cuticular membranes. Planta 180, 147-15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68E-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allmann et al. 20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Balmann C, De Oliveira S, Gutenberger A, Waßmann F, Schreiber L (2011) radioactive assay allowing the quantitative measurement of cuticular permeability of intact Arabidopsis thaliana leaves. Planta 234, 9-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Citrus limon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04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Clivia miniat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14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ecker et al. 19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Becker M, Kerstiens G, Schönherr J (1986) Water permeability of plant cuticles: permeance, diffusion and partition coefficients. Trees 1, 54-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6.81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Euonymus japonicus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55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Hedera helix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0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57865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0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de-DE" sz="500" u="none" strike="noStrike">
                          <a:effectLst/>
                        </a:rPr>
                        <a:t>Karbulková et al. 20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de-DE" sz="500" u="none" strike="noStrike">
                          <a:effectLst/>
                        </a:rPr>
                        <a:t>Karbulková J, Schreiber L, Macek P, Šantrůček J (2008) Differences between water permeability of astomatous and stomatous cuticular membranes: effects of air humidity in two species of contrasting drought-resistance strategy. J Exp Bot 59, 3987-39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4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47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66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ecker et al. 19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Becker M, Kerstiens G, Schönherr J (1986) Water permeability of plant cuticles: permeance, diffusion and partition coefficients. Trees 1, 54-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8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3.05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Kerstiens and Lendzian 19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Kerstiens G, Lendzian KJ (1989) Interactions between ozone and plant cuticles II. Water permeability. New Phytologist 112, 21-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.3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önherr and Lendzian 19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Schönherr J, Lendzian K (1981) A Simple and Inexpensive Method of Measuring Water Permeability of Isolated Plant Cuticular Membranes. Zeitschrift für Pflanzenohysiologie 102, 321-3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5.6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Kerstiens and Lendzian 19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Kerstiens G, Lendzian KJ (1989) Interactions between ozone and plant cuticles II. Water permeability. New Phytologist 112, 21-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44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allmann et al. 20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Balmann C, De Oliveira S, Gutenberger A, Waßmann F, Schreiber L (2011) radioactive assay allowing the quantitative measurement of cuticular permeability of intact Arabidopsis thaliana leaves. Planta 234, 9-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Ilex aquifolium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6.3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7.0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g</a:t>
                      </a:r>
                      <a:r>
                        <a:rPr lang="de-DE" sz="500" u="none" strike="noStrike" baseline="-25000">
                          <a:effectLst/>
                        </a:rPr>
                        <a:t>min</a:t>
                      </a:r>
                      <a:r>
                        <a:rPr lang="de-DE" sz="500" u="none" strike="noStrike">
                          <a:effectLst/>
                        </a:rPr>
                        <a:t>, Burghardt and Riederer 20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3) Ecophysiological relevance of cuticular transpiration of deciduous and evergreen plants in relation to stomatal closure and leaf water potential. Journal of Experimental Botany 54, 1941-194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1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Kerstiens and Lendzian 19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Kerstiens G, Lendzian KJ (1989) Interactions between ozone and plant cuticles II. Water permeability. New Phytologist 112, 21-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Nerium oleander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3.00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3.25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ecker et al. 19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Becker M, Kerstiens G, Schönherr J (1986) Water permeability of plant cuticles: permeance, diffusion and partition coefficients. Trees 1, 54-6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2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g</a:t>
                      </a:r>
                      <a:r>
                        <a:rPr lang="de-DE" sz="500" u="none" strike="noStrike" baseline="-25000">
                          <a:effectLst/>
                        </a:rPr>
                        <a:t>min</a:t>
                      </a:r>
                      <a:r>
                        <a:rPr lang="de-DE" sz="500" u="none" strike="noStrike">
                          <a:effectLst/>
                        </a:rPr>
                        <a:t>, Burghardt and 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500" u="none" strike="noStrike">
                          <a:effectLst/>
                        </a:rPr>
                        <a:t>Burghardt M, Riederer M (2006) Cuticular transpiration. In: Riederer M, Müller C (eds) Biology of the plant cuticle. Blackwell Publishing, Oxford, UK, 292-31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26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Olea europae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5.46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57865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Picea abies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0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500" u="none" strike="noStrike">
                          <a:effectLst/>
                        </a:rPr>
                        <a:t>g</a:t>
                      </a:r>
                      <a:r>
                        <a:rPr lang="da-DK" sz="500" u="none" strike="noStrike" baseline="-25000">
                          <a:effectLst/>
                        </a:rPr>
                        <a:t>min</a:t>
                      </a:r>
                      <a:r>
                        <a:rPr lang="da-DK" sz="500" u="none" strike="noStrike">
                          <a:effectLst/>
                        </a:rPr>
                        <a:t>, Anfodillo et al. 2002</a:t>
                      </a:r>
                      <a:endParaRPr lang="da-DK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de-DE" sz="500" u="none" strike="noStrike">
                          <a:effectLst/>
                        </a:rPr>
                        <a:t>Anfodillo T, Pasqua di Bisceglie D, Urso T (2002) Minimum cuticular conductance and cuticle features of Picea abies and Pinus cembra needles along altitudinal gradient in the Dolomites (NE Italian Alps). Tree Physiology 22, 479-48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157865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Pinus cembr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0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500" u="none" strike="noStrike">
                          <a:effectLst/>
                        </a:rPr>
                        <a:t>g</a:t>
                      </a:r>
                      <a:r>
                        <a:rPr lang="da-DK" sz="500" u="none" strike="noStrike" baseline="-25000">
                          <a:effectLst/>
                        </a:rPr>
                        <a:t>min</a:t>
                      </a:r>
                      <a:r>
                        <a:rPr lang="da-DK" sz="500" u="none" strike="noStrike">
                          <a:effectLst/>
                        </a:rPr>
                        <a:t>, Anfodillo et al. 2002</a:t>
                      </a:r>
                      <a:endParaRPr lang="da-DK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de-DE" sz="500" u="none" strike="noStrike">
                          <a:effectLst/>
                        </a:rPr>
                        <a:t>Anfodillo T, Pasqua di Bisceglie D, Urso T (2002) Minimum cuticular conductance and cuticle features of Picea abies and Pinus cembra needles along altitudinal gradient in the Dolomites (NE Italian Alps). Tree Physiology 22, 479-48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Prunus laurocerasus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5.77E-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and Riederer 19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Schreiber L, Riederer M (1996) Ecophysiology of cuticular transpiration: comparative investigation of cuticular water permeability of plant species from different habitats. Oecologia 107, 426-43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09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Riederer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Riederer M (2006) Thermodynamics of the water permeability of plant cuticles: characterization of the polar pathway. Journal of Experimental Botany 27, 2937-2942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7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Kerstiens and Lendzian 19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u="none" strike="noStrike">
                          <a:effectLst/>
                        </a:rPr>
                        <a:t>Kerstiens G, Lendzian KJ (1989) Interactions between ozone and plant cuticles II. Water permeability. New Phytologist 112, 21-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2.17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Ballmann et al. 20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Balmann C, De Oliveira S, Gutenberger A, Waßmann F, Schreiber L (2011) radioactive assay allowing the quantitative measurement of cuticular permeability of intact Arabidopsis thaliana leaves. Planta 234, 9-2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.12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chreiber 20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u="none" strike="noStrike">
                          <a:effectLst/>
                        </a:rPr>
                        <a:t>Schreiber L (2002) Co-permeability of 3 H-labelled water and 14 C-labelled organic acids across isolated Prunus laurocerasus cuticles: effect of temperature on cuticular paths of diffusion. Plant, Cell and Environemnt (2002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Median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05E-05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Upper CI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.61E-05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Lower CI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.78E-06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N species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13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N data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44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p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0.05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7 DESERT SHRUB SPECIES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6.40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Körner 1994, 19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Körner C. 1994. Scaling from species to vegetation: the usefulness of functional groups. In: Schulze ED, Mooney HA, eds. Biodiversity and ecosystem function. Berlin: Springer, 117-140.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</a:rPr>
                        <a:t>Körner C. 1995. Leaf diffusive conductances in the major vegetation types of the globe. In: Schulze ED, Caldwell MM, eds. Ecophysiology of photosynthesis. Berlin: Springer, 463-490.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DESERT GRASSES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157865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Digitaria californic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6.09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mith et al.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Smith SE, Fendenheim DM, Halbrook K (2006) Epidermal conductance as a component of dehydration avoidance in Digitaria californica and Eragrostis lehmanniana, two perennial desert grasses. Journal of Arid Environments 64, 238-25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157865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Digitaria californic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7.72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mith et al.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Smith SE, Fendenheim DM, Halbrook K (2006) Epidermal conductance as a component of dehydration avoidance in Digitaria californica and Eragrostis lehmanniana, two perennial desert grasses. Journal of Arid Environments 64, 238-25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157865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Eragrostis lehmanniana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6.51E-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Smith et al. 20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Smith SE, Fendenheim DM, Halbrook K (2006) Epidermal conductance as a component of dehydration avoidance in Digitaria californica and Eragrostis lehmanniana, two perennial desert grasses. Journal of Arid Environments 64, 238-25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3198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Mean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6.77E-05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SD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8.46E-06</a:t>
                      </a:r>
                      <a:endParaRPr lang="de-DE" sz="5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4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  <a:tr h="96651">
                <a:tc>
                  <a:txBody>
                    <a:bodyPr/>
                    <a:lstStyle/>
                    <a:p>
                      <a:pPr algn="l" fontAlgn="b"/>
                      <a:r>
                        <a:rPr lang="de-DE" sz="500" u="none" strike="noStrike">
                          <a:effectLst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4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ctr"/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de-DE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</a:tr>
            </a:tbl>
          </a:graphicData>
        </a:graphic>
      </p:graphicFrame>
      <p:sp>
        <p:nvSpPr>
          <p:cNvPr id="8" name="Textfeld 1"/>
          <p:cNvSpPr txBox="1"/>
          <p:nvPr/>
        </p:nvSpPr>
        <p:spPr>
          <a:xfrm>
            <a:off x="262618" y="812864"/>
            <a:ext cx="9075964" cy="904074"/>
          </a:xfrm>
          <a:prstGeom prst="rect">
            <a:avLst/>
          </a:prstGeom>
          <a:solidFill>
            <a:srgbClr val="92D050">
              <a:alpha val="66000"/>
            </a:srgbClr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b="1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de-DE" sz="1000" b="1" baseline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baseline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1000" b="1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iterat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heth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uticular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ermeabil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Rhazya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tricta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ood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peci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on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ser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habita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The median plus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nfidenc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imi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p = 0.05) of cuticular permeances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nimum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nductanc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 (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de-DE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of 12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ciduou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ood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plant </a:t>
            </a:r>
            <a:endParaRPr lang="de-DE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eci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1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oi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,</a:t>
            </a:r>
            <a:r>
              <a:rPr lang="de-DE" sz="10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median plus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nfidenc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imi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p = 0.05) of 13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vergree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ood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plan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peci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44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oi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, a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verag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nimu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nductanc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e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nspecifi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vergreen</a:t>
            </a:r>
            <a:r>
              <a:rPr lang="de-DE" sz="10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ser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hrub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nimum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nductanc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of 2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ser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rass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3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oi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de-DE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ocumen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Standard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altLang="de-D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anose="02020603050405020304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altLang="de-D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anose="02020603050405020304" pitchFamily="18" charset="0"/>
          </a:defRPr>
        </a:defPPr>
      </a:lstStyle>
    </a:lnDef>
  </a:objectDefaults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xmlns="" name="Präsentation1" id="{5A248AF4-AA16-4E28-804C-127A5FA550A9}" vid="{61DBD564-05D3-4B94-9F72-5ADB0487FBCC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3064</Words>
  <Application>Microsoft Macintosh PowerPoint</Application>
  <PresentationFormat>A3 Paper (297x420 mm)</PresentationFormat>
  <Paragraphs>38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Standarddesign</vt:lpstr>
      <vt:lpstr>PowerPoint Presentation</vt:lpstr>
    </vt:vector>
  </TitlesOfParts>
  <Company>Universitaet Wuerz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kus Riederer</dc:creator>
  <cp:lastModifiedBy>Office 2004 Test Drive User</cp:lastModifiedBy>
  <cp:revision>2</cp:revision>
  <dcterms:created xsi:type="dcterms:W3CDTF">2016-03-25T10:34:04Z</dcterms:created>
  <dcterms:modified xsi:type="dcterms:W3CDTF">2016-04-20T13:33:40Z</dcterms:modified>
</cp:coreProperties>
</file>